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6" d="100"/>
          <a:sy n="106" d="100"/>
        </p:scale>
        <p:origin x="-243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50305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08571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45952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00078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26109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54626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4729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79640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15797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26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0898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3CB8F-F466-4CBF-A3DE-D72136E652CF}" type="datetimeFigureOut">
              <a:rPr lang="sv-SE" smtClean="0"/>
              <a:t>2014-07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C9505-3CD6-4B53-BA98-F1480EC7BD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79889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36712" y="7524328"/>
            <a:ext cx="51435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S1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Graphica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illustration of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ll significantly enriched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ene ontology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(GO) terms and their internal relationships for the 841 overlapped proteins identified in cyst fluids. Each GO term is represented by a colored circle: the similar size indicates p&lt;0.01 for all GO terms and the color </a:t>
            </a:r>
            <a:r>
              <a:rPr lang="en-US" sz="1200">
                <a:latin typeface="Arial" pitchFamily="34" charset="0"/>
                <a:cs typeface="Arial" pitchFamily="34" charset="0"/>
              </a:rPr>
              <a:t>intensity </a:t>
            </a:r>
            <a:r>
              <a:rPr lang="en-US" sz="1200" smtClean="0">
                <a:latin typeface="Arial" pitchFamily="34" charset="0"/>
                <a:cs typeface="Arial" pitchFamily="34" charset="0"/>
              </a:rPr>
              <a:t>indicates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he frequency of GO terms. Connected circles demonstrate highly related GO terms, and the width of the connecting lines is positively correlated to the degree of similarity.</a:t>
            </a:r>
            <a:endParaRPr lang="sv-SE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672" y="107504"/>
            <a:ext cx="5947557" cy="7264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7009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enter for Molecular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mporary account</dc:creator>
  <cp:lastModifiedBy>andrii</cp:lastModifiedBy>
  <cp:revision>6</cp:revision>
  <dcterms:created xsi:type="dcterms:W3CDTF">2014-07-02T14:18:34Z</dcterms:created>
  <dcterms:modified xsi:type="dcterms:W3CDTF">2014-07-04T15:59:30Z</dcterms:modified>
</cp:coreProperties>
</file>